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0" r:id="rId2"/>
    <p:sldId id="321" r:id="rId3"/>
    <p:sldId id="322" r:id="rId4"/>
    <p:sldId id="323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32" d="100"/>
          <a:sy n="132" d="100"/>
        </p:scale>
        <p:origin x="105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900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462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783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335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562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303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905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655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075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39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824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D18E2-52FC-4EA1-8ED1-751372441951}" type="datetimeFigureOut">
              <a:rPr lang="en-US" smtClean="0"/>
              <a:t>3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AE6774-7660-4BA6-B607-D5F24DE3F0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087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F41C9D97-0F1F-46C9-9E5F-D079E6E6E4B5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764030" y="455037"/>
            <a:ext cx="5615940" cy="403034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B6D52794-A4E6-4CC0-A218-978A7E5F1586}"/>
              </a:ext>
            </a:extLst>
          </p:cNvPr>
          <p:cNvSpPr/>
          <p:nvPr/>
        </p:nvSpPr>
        <p:spPr>
          <a:xfrm>
            <a:off x="2286000" y="4988729"/>
            <a:ext cx="4572000" cy="1248355"/>
          </a:xfrm>
          <a:prstGeom prst="rect">
            <a:avLst/>
          </a:prstGeom>
        </p:spPr>
        <p:txBody>
          <a:bodyPr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 analysis of PSD-enriched vs. P2 samples for wild-type (WT) and Shank3B knockout (KO) samples. A) Samples were probed with primary antibodies PSD-95 (PSD marker), GAPDH (cytosolic marker), and 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hibitin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mitochondrial marker). B) Immunoblot quantitation was performed by normalizing protein intensities to control sample (C) within the same immunoblot. Plotted values are the relative normalized intensities of PSD-95 to GAPDH for both wild-type (blue) and KO (purple) samples.</a:t>
            </a:r>
          </a:p>
        </p:txBody>
      </p:sp>
    </p:spTree>
    <p:extLst>
      <p:ext uri="{BB962C8B-B14F-4D97-AF65-F5344CB8AC3E}">
        <p14:creationId xmlns:p14="http://schemas.microsoft.com/office/powerpoint/2010/main" val="411916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8BB17C16-F111-4E68-ABC9-F5403877993C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764030" y="1711697"/>
            <a:ext cx="5615940" cy="197866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44622CA7-1A71-4AEE-9574-F9C4C984BDBB}"/>
              </a:ext>
            </a:extLst>
          </p:cNvPr>
          <p:cNvSpPr/>
          <p:nvPr/>
        </p:nvSpPr>
        <p:spPr>
          <a:xfrm>
            <a:off x="2010789" y="4037960"/>
            <a:ext cx="4572000" cy="925894"/>
          </a:xfrm>
          <a:prstGeom prst="rect">
            <a:avLst/>
          </a:prstGeom>
        </p:spPr>
        <p:txBody>
          <a:bodyPr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 analysis of PSD-enriched vs. pre-fractionation (PF) samples. A) Samples were probed with primary antibodies PSD-95 (PSD marker), GAPDH (cytosolic marker), and </a:t>
            </a:r>
            <a:r>
              <a:rPr lang="en-US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hibitin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mitochondrial marker). B) Immunoblot quantitation was 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D-95 to GAPDH for both Pre-fractionation (grey) and PSD-enriched (green) samples.</a:t>
            </a:r>
          </a:p>
        </p:txBody>
      </p:sp>
    </p:spTree>
    <p:extLst>
      <p:ext uri="{BB962C8B-B14F-4D97-AF65-F5344CB8AC3E}">
        <p14:creationId xmlns:p14="http://schemas.microsoft.com/office/powerpoint/2010/main" val="36240915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wpc="http://schemas.microsoft.com/office/word/2010/wordprocessingCanvas" xmlns:mc="http://schemas.openxmlformats.org/markup-compatibility/2006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16="http://schemas.microsoft.com/office/drawing/2014/main" xmlns:w16se="http://schemas.microsoft.com/office/word/2015/wordml/symex" xmlns:w16cid="http://schemas.microsoft.com/office/word/2016/wordml/cid" xmlns:w="http://schemas.openxmlformats.org/wordprocessingml/2006/main" xmlns:w10="urn:schemas-microsoft-com:office:word" xmlns:v="urn:schemas-microsoft-com:vml" xmlns:o="urn:schemas-microsoft-com:office:office" xmlns:am3d="http://schemas.microsoft.com/office/drawing/2017/model3d" xmlns:aink="http://schemas.microsoft.com/office/drawing/2016/ink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="" xmlns:lc="http://schemas.openxmlformats.org/drawingml/2006/lockedCanvas" id="{25F6F805-93DB-42A5-A985-1C2253010C48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4030" y="670004"/>
            <a:ext cx="5615940" cy="44831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2165497" y="5399071"/>
            <a:ext cx="4572000" cy="1092607"/>
          </a:xfrm>
          <a:prstGeom prst="rect">
            <a:avLst/>
          </a:prstGeom>
        </p:spPr>
        <p:txBody>
          <a:bodyPr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9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M data correction with mean-intensity normalization. A) Total protein abundance values and B) mean-normalized protein abundance values for pre-fractionated (purple) and PSD-enriched (green) samples. C) Total protein abundance values and D) mean-normalized protein abundance values for wild-type (WT) (red) and Shank3 knockout (KO) (blue) samples. 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91517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286000" y="3715414"/>
            <a:ext cx="4572000" cy="592470"/>
          </a:xfrm>
          <a:prstGeom prst="rect">
            <a:avLst/>
          </a:prstGeom>
        </p:spPr>
        <p:txBody>
          <a:bodyPr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9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r>
              <a:rPr lang="en-US" sz="9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hank3 PRM target peptide conservation in the ten expressed mouse Shank3 isoforms. The table indicates the presence (green) or absence (red) of the tryptic peptide in each isoform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0519" y="2022546"/>
            <a:ext cx="5762963" cy="1332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8458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00</TotalTime>
  <Words>258</Words>
  <Application>Microsoft Office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shaun Wilson</dc:creator>
  <cp:lastModifiedBy>Wilson, Rashaun</cp:lastModifiedBy>
  <cp:revision>8</cp:revision>
  <dcterms:created xsi:type="dcterms:W3CDTF">2019-02-09T17:19:53Z</dcterms:created>
  <dcterms:modified xsi:type="dcterms:W3CDTF">2019-03-11T18:22:35Z</dcterms:modified>
</cp:coreProperties>
</file>